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70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49C3A6-06A7-5E93-45DC-256BFBB249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777C776-8D1C-4D90-4E8F-4BD89B233D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68D00FE-4BED-2E1C-5015-C571FA8D1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EF94E-2E53-4ED0-9435-A437002DE9EF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5E3036-EDBD-3D39-7A85-1AEBC8F10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1C770A-BF85-B004-0788-A5F79A1D6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824AA-F285-4706-A39C-3353B59F1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9315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239AA7-3798-E60E-F84E-50C52BFF56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6EBA138-7B73-1F36-FBD8-5DA96EED77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D07A9C6-456F-68B2-A3E3-AC5942C65A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EF94E-2E53-4ED0-9435-A437002DE9EF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B4B1F5-713A-C177-59DD-6BA17A176E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2352837-B82D-5A8E-5F87-BE4417740A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824AA-F285-4706-A39C-3353B59F1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2729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6E04396-1A1C-826C-9D12-746F4146C7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8028987-7014-A0D4-F3AF-0E9BE599E6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C200BF1-E07F-508B-41C0-B398F8FB80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EF94E-2E53-4ED0-9435-A437002DE9EF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D1B6DE-77A7-E90F-455F-7FA0A0F6B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8158C4-A665-5CFE-211A-DD7291346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824AA-F285-4706-A39C-3353B59F1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7396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43ABB2-8650-B3C8-A641-73373D033B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D649964-0FAE-C511-F651-00F18EAFA3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44168C9-12F0-D000-267D-E9637C79A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EF94E-2E53-4ED0-9435-A437002DE9EF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4141BE5-70B1-BB92-2363-4678D6A7B7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F12D9B-6EA9-E961-F81D-599FE13CD8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824AA-F285-4706-A39C-3353B59F1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6245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15B1F3-FFFA-AAC0-E071-994AAA7C00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27BE645-831A-951D-9018-EFF2B239BC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AC0D11-8832-9B1D-0AF8-A393B15C8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EF94E-2E53-4ED0-9435-A437002DE9EF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91D1785-11AE-E938-D184-240248FC2B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A0E0E5-6BF2-896D-F44A-240848884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824AA-F285-4706-A39C-3353B59F1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6134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CAC606-E0BF-8CD8-05B9-EF2C995045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8427DC6-293D-C060-6C57-FC57820F27F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2E93DED-C51E-1715-813F-F9E4F642B0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AFDADEA-82A5-950B-7FA5-73AD001B1A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EF94E-2E53-4ED0-9435-A437002DE9EF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CEA3CD4-A902-33FF-6A2C-6FDC61693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0FC4C58-05BE-2015-3DA7-7225BE24D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824AA-F285-4706-A39C-3353B59F1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5719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683B45-0E0A-9E99-35F7-2A0FC94055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BA34666-9182-6A68-A8E1-0C1ECAF6B3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5E41526-DAF2-6F6C-FF55-8EC65141EB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73ABF66-B14F-C559-3822-94EE524F391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0054C2F-191D-B7FA-7DF0-CB17A64CBE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F169E45-E74C-2BC6-693E-4DE3463DB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EF94E-2E53-4ED0-9435-A437002DE9EF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C3B44D2-850D-6385-AA6E-3AD3CCDAC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F28383E-EE36-C0DE-1A73-5F02A8205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824AA-F285-4706-A39C-3353B59F1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1037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DA49D2-1569-E513-E067-7E96B3AEB9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856EF51-9825-86E5-7F46-70950F55C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EF94E-2E53-4ED0-9435-A437002DE9EF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252D2E4-C6A6-DAA1-A82C-1FF0BE90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805EB43-14F7-BCF2-3738-B6F19BC0AB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824AA-F285-4706-A39C-3353B59F1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9205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568EB96-DF27-05B9-CCA1-07B8ECC1C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EF94E-2E53-4ED0-9435-A437002DE9EF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8E30D54-E499-A703-ED07-0A41C53DA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CCCF11E-57F5-879C-D108-3CCA468D7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824AA-F285-4706-A39C-3353B59F1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1346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23886E-581D-86D5-5D2C-5075142C95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C8E4DED-FFEA-DBD5-40CE-32765235E4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A5B8948-2547-0C0B-5358-43D3325D55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605D79A-F928-1E7D-A75C-583CE58F2C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EF94E-2E53-4ED0-9435-A437002DE9EF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AF8CC69-A6DC-A8F4-5AA0-68431FC8E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1B58733-75F2-81F2-D629-6B055A4DA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824AA-F285-4706-A39C-3353B59F1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6618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5BC651-6218-4529-1C18-82330EEE31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13E4276-C162-1ADF-628E-D6085512B5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9F8E52B-C17B-E008-B32D-C452C6099A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302514B-1F5F-E4E0-0CE3-C6A9D9F08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FEF94E-2E53-4ED0-9435-A437002DE9EF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F13ABE4-3342-811A-3643-0E834F92C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AB27246-A867-7613-1067-FFBECFED7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D824AA-F285-4706-A39C-3353B59F1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27324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FA91411-7D57-EA37-2E41-F9C6BBDFC1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9C610FD-9B6C-0C4D-E7CE-9D7549F1D1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DBF512F-0DAE-5ECF-F0E4-98140E676B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FEF94E-2E53-4ED0-9435-A437002DE9EF}" type="datetimeFigureOut">
              <a:rPr lang="zh-CN" altLang="en-US" smtClean="0"/>
              <a:t>2024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D81DAE-1ECA-8932-B1CF-9025554D6E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1BBC03-97D4-209C-CAF2-1A773E9B19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D824AA-F285-4706-A39C-3353B59F147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6929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B198E96F-289D-8A32-4467-0B3602E526B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938534" y="446139"/>
            <a:ext cx="6314932" cy="5422531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81DE347-B60A-6EF6-584F-A5A2833B52B9}"/>
              </a:ext>
            </a:extLst>
          </p:cNvPr>
          <p:cNvSpPr txBox="1"/>
          <p:nvPr/>
        </p:nvSpPr>
        <p:spPr>
          <a:xfrm>
            <a:off x="3048000" y="586867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Figure 6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. Performance of GPT-3.5 in the medical licensing exam</a:t>
            </a:r>
            <a:r>
              <a:rPr lang="en-US" altLang="zh-CN" kern="100" dirty="0"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.</a:t>
            </a:r>
            <a:endParaRPr lang="zh-CN" altLang="zh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94839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D793453-18BC-B821-4CFE-557A08DF88DD}"/>
              </a:ext>
            </a:extLst>
          </p:cNvPr>
          <p:cNvSpPr txBox="1"/>
          <p:nvPr/>
        </p:nvSpPr>
        <p:spPr>
          <a:xfrm>
            <a:off x="3048000" y="586867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Figure 15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. Sensitivity analyses result from the performance of GPT-3.5 and GPT-4.</a:t>
            </a:r>
            <a:endParaRPr lang="zh-CN" altLang="zh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80F2038-BD73-6284-D6E3-D4EBD4F0BF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5293" y="171793"/>
            <a:ext cx="4341413" cy="569687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7034373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4698FCD4-1D06-C29C-5D3D-E01BB99DF762}"/>
              </a:ext>
            </a:extLst>
          </p:cNvPr>
          <p:cNvSpPr txBox="1"/>
          <p:nvPr/>
        </p:nvSpPr>
        <p:spPr>
          <a:xfrm>
            <a:off x="3048000" y="5868670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Figure 7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. Performance of GPT-4 in the medical licensing exam.</a:t>
            </a:r>
            <a:endParaRPr lang="zh-CN" altLang="zh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7F6BB95-8554-DD08-A219-D93EF3CAA7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300489" y="342999"/>
            <a:ext cx="5591021" cy="549046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3835281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8B8E720-88F6-EA0E-0E4F-C3B15A56E879}"/>
              </a:ext>
            </a:extLst>
          </p:cNvPr>
          <p:cNvSpPr txBox="1"/>
          <p:nvPr/>
        </p:nvSpPr>
        <p:spPr>
          <a:xfrm>
            <a:off x="3048000" y="5868670"/>
            <a:ext cx="60960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Figure 8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. Subgroup 1: Performance of GPT-3.5 on the medical licensing exam from English-speaking countries and non-English-speaking countries.</a:t>
            </a:r>
            <a:endParaRPr lang="zh-CN" altLang="zh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E95BD97-BF73-F70A-7E90-E8E2B01F0A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31342" y="190298"/>
            <a:ext cx="4729316" cy="549920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9804304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D9765E7-5EE2-EE83-28F6-A67B95FC68E6}"/>
              </a:ext>
            </a:extLst>
          </p:cNvPr>
          <p:cNvSpPr txBox="1"/>
          <p:nvPr/>
        </p:nvSpPr>
        <p:spPr>
          <a:xfrm>
            <a:off x="3048000" y="5868670"/>
            <a:ext cx="60960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Figure 9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. Subgroup 1: Performance of GPT-4 on the medical licensing exam from English-speaking countries and non-English-speaking countries.</a:t>
            </a:r>
            <a:endParaRPr lang="zh-CN" altLang="zh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7E3F5E8-DCA8-D4CC-2686-5C9273535AD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36258" y="199038"/>
            <a:ext cx="4719483" cy="5669632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87415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7E5F026-3767-4C96-EE11-E63D3A2D8FA2}"/>
              </a:ext>
            </a:extLst>
          </p:cNvPr>
          <p:cNvSpPr txBox="1"/>
          <p:nvPr/>
        </p:nvSpPr>
        <p:spPr>
          <a:xfrm>
            <a:off x="3048000" y="586867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Figure 10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. Subgroup 2: Performance of GPT-3.5 with or without prompts.</a:t>
            </a:r>
            <a:endParaRPr lang="zh-CN" altLang="zh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410642D-EC63-D01A-46A4-4182D0687B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1647" y="150518"/>
            <a:ext cx="4888706" cy="5718152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1216377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97C8413-3A95-98A6-D1F5-B48B435AB459}"/>
              </a:ext>
            </a:extLst>
          </p:cNvPr>
          <p:cNvSpPr txBox="1"/>
          <p:nvPr/>
        </p:nvSpPr>
        <p:spPr>
          <a:xfrm>
            <a:off x="3048000" y="586867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Figure 11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. Subgroup 2: Performance of GPT-4 with or without prompts.</a:t>
            </a:r>
            <a:endParaRPr lang="zh-CN" altLang="zh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1833950-4AB6-763E-49CD-73581060FC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5643" y="45633"/>
            <a:ext cx="4640714" cy="585253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8930379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7492C589-2781-6C68-1899-AF3FD47D4538}"/>
              </a:ext>
            </a:extLst>
          </p:cNvPr>
          <p:cNvSpPr txBox="1"/>
          <p:nvPr/>
        </p:nvSpPr>
        <p:spPr>
          <a:xfrm>
            <a:off x="3048000" y="586867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Figure 12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. Subgroup 3: Performance of GPT-3.5 regarding “Flow and Timing.”</a:t>
            </a:r>
            <a:endParaRPr lang="zh-CN" altLang="zh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B617A4D-2BE7-BA47-AA8F-0E0907E02B0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2516" y="221411"/>
            <a:ext cx="4866968" cy="564725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8237453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D793453-18BC-B821-4CFE-557A08DF88DD}"/>
              </a:ext>
            </a:extLst>
          </p:cNvPr>
          <p:cNvSpPr txBox="1"/>
          <p:nvPr/>
        </p:nvSpPr>
        <p:spPr>
          <a:xfrm>
            <a:off x="3048000" y="586867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Figure 13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. Subgroup 3: Performance of GPT-4 regarding “Flow and Timing.”</a:t>
            </a:r>
            <a:endParaRPr lang="zh-CN" altLang="zh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3942B00-BA0D-36EC-AD20-A2619A4CED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8658" y="148298"/>
            <a:ext cx="4414683" cy="5720372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5749367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D793453-18BC-B821-4CFE-557A08DF88DD}"/>
              </a:ext>
            </a:extLst>
          </p:cNvPr>
          <p:cNvSpPr txBox="1"/>
          <p:nvPr/>
        </p:nvSpPr>
        <p:spPr>
          <a:xfrm>
            <a:off x="3048000" y="5868670"/>
            <a:ext cx="6096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Figure 14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Arial" panose="020B0604020202020204" pitchFamily="34" charset="0"/>
              </a:rPr>
              <a:t>. A funnel plot of the included studies reported GPT-3.5 and GPT-4 performance.</a:t>
            </a:r>
            <a:endParaRPr lang="zh-CN" altLang="zh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704067B-74D6-FDA7-02C5-24178C80106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5666" y="1708215"/>
            <a:ext cx="10020667" cy="323833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2602872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154</Words>
  <Application>Microsoft Office PowerPoint</Application>
  <PresentationFormat>宽屏</PresentationFormat>
  <Paragraphs>10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6" baseType="lpstr">
      <vt:lpstr>等线</vt:lpstr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U　Mingxin</dc:creator>
  <cp:lastModifiedBy>LIU　Mingxin</cp:lastModifiedBy>
  <cp:revision>1</cp:revision>
  <dcterms:created xsi:type="dcterms:W3CDTF">2024-06-29T01:26:10Z</dcterms:created>
  <dcterms:modified xsi:type="dcterms:W3CDTF">2024-06-29T02:08:55Z</dcterms:modified>
</cp:coreProperties>
</file>